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0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ya Engler" userId="1252e1b0b8bb23a8" providerId="LiveId" clId="{194E3EB3-A07B-4080-9C6B-B04CE0C20AEA}"/>
    <pc:docChg chg="undo custSel modSld">
      <pc:chgData name="Maya Engler" userId="1252e1b0b8bb23a8" providerId="LiveId" clId="{194E3EB3-A07B-4080-9C6B-B04CE0C20AEA}" dt="2025-06-17T07:33:27.877" v="78" actId="20577"/>
      <pc:docMkLst>
        <pc:docMk/>
      </pc:docMkLst>
      <pc:sldChg chg="modSp mod">
        <pc:chgData name="Maya Engler" userId="1252e1b0b8bb23a8" providerId="LiveId" clId="{194E3EB3-A07B-4080-9C6B-B04CE0C20AEA}" dt="2025-06-17T07:33:27.877" v="78" actId="20577"/>
        <pc:sldMkLst>
          <pc:docMk/>
          <pc:sldMk cId="1363550224" sldId="256"/>
        </pc:sldMkLst>
        <pc:graphicFrameChg chg="mod modGraphic">
          <ac:chgData name="Maya Engler" userId="1252e1b0b8bb23a8" providerId="LiveId" clId="{194E3EB3-A07B-4080-9C6B-B04CE0C20AEA}" dt="2025-06-17T07:33:27.877" v="78" actId="20577"/>
          <ac:graphicFrameMkLst>
            <pc:docMk/>
            <pc:sldMk cId="1363550224" sldId="256"/>
            <ac:graphicFrameMk id="4" creationId="{1E08D1C5-1C5A-964A-A3A8-5C5B098E93A7}"/>
          </ac:graphicFrameMkLst>
        </pc:graphicFrameChg>
        <pc:graphicFrameChg chg="mod modGraphic">
          <ac:chgData name="Maya Engler" userId="1252e1b0b8bb23a8" providerId="LiveId" clId="{194E3EB3-A07B-4080-9C6B-B04CE0C20AEA}" dt="2025-06-17T07:32:24.403" v="44" actId="1076"/>
          <ac:graphicFrameMkLst>
            <pc:docMk/>
            <pc:sldMk cId="1363550224" sldId="256"/>
            <ac:graphicFrameMk id="5" creationId="{9C5B1297-EA62-9120-E0B0-ED6B06089E5A}"/>
          </ac:graphicFrameMkLst>
        </pc:graphicFrameChg>
        <pc:graphicFrameChg chg="mod">
          <ac:chgData name="Maya Engler" userId="1252e1b0b8bb23a8" providerId="LiveId" clId="{194E3EB3-A07B-4080-9C6B-B04CE0C20AEA}" dt="2025-06-09T11:27:25.904" v="4" actId="1076"/>
          <ac:graphicFrameMkLst>
            <pc:docMk/>
            <pc:sldMk cId="1363550224" sldId="256"/>
            <ac:graphicFrameMk id="6" creationId="{8CA27C94-42FE-9EE5-3843-B14A20F7884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07934A4E-45C8-DC35-AD15-2FA17CCACC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7ABB930D-EE98-4BDE-AA0E-8338A48151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665772B-AE95-66E6-D879-AA184FFCF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07FB0D70-2D50-F120-50F1-BEE02DA38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4301C858-A90B-CAA6-CE8A-CEE52C487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53466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D741F0D-8726-EB15-684F-5D00B7BB4E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A5EE6C02-E315-7A34-3FE9-F28CECFDDE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EEE3734D-A61B-256F-82F0-D9E0CF8A0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24E27438-FC73-2F6F-04E0-47C5C24DC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B0708B9C-5A40-DF81-02A0-C8C74F8A4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41508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0EB8AFDC-A997-07F7-8BC1-2BD8EB560F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E56579C6-7E17-8F9C-CC6A-F67ECB5BDE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29488882-4082-E882-C29E-313208D56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74249E7-F67E-7CB7-36EF-DF507D849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E5713DE4-5438-F0C2-9BAC-D6D1B0E14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47129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60FC69F-9794-35B0-2135-639E26EF7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7F80D25F-06A4-E6FF-A9E2-91A0DAE80C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BF52AD5-7A1A-EBEA-0181-BE3715131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8C230354-C388-CA37-CD93-B0E2AA1FF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7A3D38F5-899D-11E9-585A-C634F4595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19691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8F935AF-AA0D-EA83-8202-50CB0F6D9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C0DABD24-592A-177A-F2ED-55BBC7BF2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F10FD672-CE68-6E86-ACA4-936FC2C72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5903C973-9149-024C-C7CB-0779F723E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9C6E1FE4-FA67-B75E-2FA0-927A83B7D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01083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C841C58C-0C6B-E2D6-21B2-0C0D9A0BB2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7AE7D635-65A3-5A88-5BB9-C045CE298A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DD05E466-737D-E385-0591-D8D7293E71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FB55C688-ABF1-3200-ABD2-A6EAB38DA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B70443AA-27A5-BC34-1345-AD01B30B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3DE27281-238C-A05B-7DF8-FDEFFCF6C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38259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685A3247-2B71-0D19-962B-CE933F269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911BA952-FE34-372D-4B77-27860CB8EC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8F635AB7-398F-C91C-20CE-6407EDF363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C7C8F716-516D-2182-5144-BCD0A7E544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939C6281-9B1C-62AA-194D-F93A9F4AF9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2801D44D-7838-0B54-CB4B-78E53C6D4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662E5FE8-3724-0CC5-38FF-DCA7E6AEC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8CB5B8DF-2539-DB63-1677-11A74D43B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93475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909382F-C355-C63B-8486-266399C5DA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79E43F54-322C-4DC2-E5F4-17C5DC3B7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48BD9FF1-58FB-9BF9-36E4-8C73A501B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0EA7653C-0879-8304-AC73-E15C7F65A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17427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EED7EA0A-D028-D354-D61A-891FBC578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197B54F5-03EF-240C-5257-1E4DB1099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59E608CF-84B6-F099-1604-13FFC341F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46672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B1B7A22-E425-1694-6B77-1F9D13C4F9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383F9210-00A7-912B-D08C-AEEC994C74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027697A5-CC74-0048-2D1D-6FAB0A980C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39B2F0FC-7489-E7BF-BF80-FB5F8E0BC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0C605EE5-3DB3-EEDA-4CEA-744E3EC77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12FA66F7-08B9-5AE4-3A11-2CAD656CA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5775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A5628B62-072A-AA00-DB8E-BCFD1AE30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B1BB6B39-2FE0-35A8-699C-F435DD0BDB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9F44C8F9-82D8-96B1-8D5A-EB982BCB57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11397B60-1378-C572-5378-7811736FF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F3D7CDAF-05A3-A051-E051-23478CE64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4C03F7AB-63C1-1208-F38A-11483AB7F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5035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1BC9E0B7-1021-5A79-B021-01F41234F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0CA03BD2-4805-E99B-4A95-3EAB35AE19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FA810EEB-5B89-3300-3C0D-2B65B8A3A1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BC0C2A-B4D6-4A47-9C68-92D789CB6A29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6713D3D5-C9C7-64D8-DF62-DFD56E1E7A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0B2B367-BD8D-C8E9-58C7-8C213CA7D5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40EED95-EA88-474E-848D-37245C71DF7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4087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1E08D1C5-1C5A-964A-A3A8-5C5B098E93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9912926"/>
              </p:ext>
            </p:extLst>
          </p:nvPr>
        </p:nvGraphicFramePr>
        <p:xfrm>
          <a:off x="321564" y="399161"/>
          <a:ext cx="5012436" cy="20193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7736">
                  <a:extLst>
                    <a:ext uri="{9D8B030D-6E8A-4147-A177-3AD203B41FA5}">
                      <a16:colId xmlns:a16="http://schemas.microsoft.com/office/drawing/2014/main" val="13528548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914247942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398860241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237552289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566238669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488568044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18929702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87433905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925151510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3390761283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tho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2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3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4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5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6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7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8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 dirty="0">
                          <a:effectLst/>
                        </a:rPr>
                        <a:t>9</a:t>
                      </a:r>
                      <a:endParaRPr lang="he-IL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0233270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Parrish et al. [37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/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73890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Faurschou et al. [38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92D05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363965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</a:rPr>
                        <a:t>Monfrecola</a:t>
                      </a:r>
                      <a:r>
                        <a:rPr lang="en-US" sz="1100" u="none" strike="noStrike" dirty="0">
                          <a:effectLst/>
                        </a:rPr>
                        <a:t> et al. [39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597041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</a:rPr>
                        <a:t>Calzavara-Pinton</a:t>
                      </a:r>
                      <a:r>
                        <a:rPr lang="en-US" sz="1100" u="none" strike="noStrike" dirty="0">
                          <a:effectLst/>
                        </a:rPr>
                        <a:t> et al. [40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162166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Bernhard et al. [41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767943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Keahey et al. [42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61841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ddo et al. [7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557176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bin et al. [43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486201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bin et al. [44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>
                          <a:effectLst/>
                        </a:rPr>
                        <a:t> </a:t>
                      </a:r>
                      <a:endParaRPr lang="he-IL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540998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</a:t>
                      </a:r>
                      <a:r>
                        <a:rPr lang="en-US" sz="1100" u="none" strike="noStrike" dirty="0" err="1">
                          <a:effectLst/>
                        </a:rPr>
                        <a:t>Caccialanza</a:t>
                      </a:r>
                      <a:r>
                        <a:rPr lang="en-US" sz="1100" u="none" strike="noStrike" dirty="0">
                          <a:effectLst/>
                        </a:rPr>
                        <a:t> et al. </a:t>
                      </a:r>
                      <a:r>
                        <a:rPr lang="en-US" sz="1100" u="none" strike="noStrike">
                          <a:effectLst/>
                        </a:rPr>
                        <a:t>[45]</a:t>
                      </a:r>
                      <a:endParaRPr lang="en-US" sz="1100" b="0" i="0" u="none" strike="noStrike" dirty="0">
                        <a:solidFill>
                          <a:srgbClr val="EE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he-IL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2455197"/>
                  </a:ext>
                </a:extLst>
              </a:tr>
            </a:tbl>
          </a:graphicData>
        </a:graphic>
      </p:graphicFrame>
      <p:graphicFrame>
        <p:nvGraphicFramePr>
          <p:cNvPr id="5" name="טבלה 4">
            <a:extLst>
              <a:ext uri="{FF2B5EF4-FFF2-40B4-BE49-F238E27FC236}">
                <a16:creationId xmlns:a16="http://schemas.microsoft.com/office/drawing/2014/main" id="{9C5B1297-EA62-9120-E0B0-ED6B06089E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8209585"/>
              </p:ext>
            </p:extLst>
          </p:nvPr>
        </p:nvGraphicFramePr>
        <p:xfrm>
          <a:off x="5537202" y="1866011"/>
          <a:ext cx="1320800" cy="5524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02577004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5438820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204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8475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ncl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458592"/>
                  </a:ext>
                </a:extLst>
              </a:tr>
            </a:tbl>
          </a:graphicData>
        </a:graphic>
      </p:graphicFrame>
      <p:graphicFrame>
        <p:nvGraphicFramePr>
          <p:cNvPr id="6" name="טבלה 5">
            <a:extLst>
              <a:ext uri="{FF2B5EF4-FFF2-40B4-BE49-F238E27FC236}">
                <a16:creationId xmlns:a16="http://schemas.microsoft.com/office/drawing/2014/main" id="{8CA27C94-42FE-9EE5-3843-B14A20F788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3794552"/>
              </p:ext>
            </p:extLst>
          </p:nvPr>
        </p:nvGraphicFramePr>
        <p:xfrm>
          <a:off x="321564" y="2619375"/>
          <a:ext cx="8877300" cy="16192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673220967"/>
                    </a:ext>
                  </a:extLst>
                </a:gridCol>
                <a:gridCol w="8216900">
                  <a:extLst>
                    <a:ext uri="{9D8B030D-6E8A-4147-A177-3AD203B41FA5}">
                      <a16:colId xmlns:a16="http://schemas.microsoft.com/office/drawing/2014/main" val="2412648975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 it clear in the study what is the “cause” and what is the “effect”?</a:t>
                      </a:r>
                      <a:endParaRPr lang="en-US" sz="11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399847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as there a control group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1849915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ere participants included in any comparable comparisons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4488684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part from the relevant exposure or intervention, were the participants in any comparisons receiving comparable care or treatment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9385486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ere there several assessments of the result before and after the exposure or intervention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2795241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id all comparisons use the same measurement for participant outcomes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2505120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ere results measured with accuracy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042628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f not, were the follow-up differences between groups sufficiently explained and examined? Was the follow-up complete?</a:t>
                      </a:r>
                      <a:endParaRPr lang="en-US" sz="11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0044349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Was appropriate statistical analysis used?</a:t>
                      </a:r>
                      <a:endParaRPr lang="en-US" sz="11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491864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63550224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99</Words>
  <Application>Microsoft Office PowerPoint</Application>
  <PresentationFormat>מסך רחב</PresentationFormat>
  <Paragraphs>125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ערכת נושא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ya Engler</dc:creator>
  <cp:lastModifiedBy>Maya Engler</cp:lastModifiedBy>
  <cp:revision>1</cp:revision>
  <dcterms:created xsi:type="dcterms:W3CDTF">2025-06-09T10:32:16Z</dcterms:created>
  <dcterms:modified xsi:type="dcterms:W3CDTF">2025-06-17T07:33:28Z</dcterms:modified>
</cp:coreProperties>
</file>